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6" autoAdjust="0"/>
    <p:restoredTop sz="94660"/>
  </p:normalViewPr>
  <p:slideViewPr>
    <p:cSldViewPr snapToGrid="0">
      <p:cViewPr varScale="1">
        <p:scale>
          <a:sx n="48" d="100"/>
          <a:sy n="48" d="100"/>
        </p:scale>
        <p:origin x="2092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obert Schaffer" userId="30379af1-9b08-43f5-b0a6-5fbc9da7bcf5" providerId="ADAL" clId="{E14245E8-6EA3-47DE-B56A-424FFF16A273}"/>
    <pc:docChg chg="delSld">
      <pc:chgData name="Robert Schaffer" userId="30379af1-9b08-43f5-b0a6-5fbc9da7bcf5" providerId="ADAL" clId="{E14245E8-6EA3-47DE-B56A-424FFF16A273}" dt="2025-01-06T01:16:39.819" v="1" actId="47"/>
      <pc:docMkLst>
        <pc:docMk/>
      </pc:docMkLst>
      <pc:sldChg chg="del">
        <pc:chgData name="Robert Schaffer" userId="30379af1-9b08-43f5-b0a6-5fbc9da7bcf5" providerId="ADAL" clId="{E14245E8-6EA3-47DE-B56A-424FFF16A273}" dt="2025-01-06T01:16:37.667" v="0" actId="47"/>
        <pc:sldMkLst>
          <pc:docMk/>
          <pc:sldMk cId="3609519590" sldId="256"/>
        </pc:sldMkLst>
      </pc:sldChg>
      <pc:sldChg chg="del">
        <pc:chgData name="Robert Schaffer" userId="30379af1-9b08-43f5-b0a6-5fbc9da7bcf5" providerId="ADAL" clId="{E14245E8-6EA3-47DE-B56A-424FFF16A273}" dt="2025-01-06T01:16:39.819" v="1" actId="47"/>
        <pc:sldMkLst>
          <pc:docMk/>
          <pc:sldMk cId="1090110272" sldId="262"/>
        </pc:sldMkLst>
      </pc:sldChg>
      <pc:sldChg chg="del">
        <pc:chgData name="Robert Schaffer" userId="30379af1-9b08-43f5-b0a6-5fbc9da7bcf5" providerId="ADAL" clId="{E14245E8-6EA3-47DE-B56A-424FFF16A273}" dt="2025-01-06T01:16:37.667" v="0" actId="47"/>
        <pc:sldMkLst>
          <pc:docMk/>
          <pc:sldMk cId="93960508" sldId="26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66593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778704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774208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71107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795874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644812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35045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95551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601934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716858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02258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8357367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269765" y="3643093"/>
            <a:ext cx="6032092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NZ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NZ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NZ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NZ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ata from </a:t>
            </a:r>
            <a:r>
              <a:rPr lang="en-NZ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NZ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plus an additional wildtype and A5 and A6 lines between 80 </a:t>
            </a:r>
            <a:r>
              <a:rPr lang="en-NZ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NZ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FB (week 1) and 172 DAFB (week 25) or until fruit-fall.  </a:t>
            </a:r>
            <a:r>
              <a:rPr lang="en-NZ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wess</a:t>
            </a:r>
            <a:r>
              <a:rPr lang="en-NZ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moothing curves are shown in black. Hue angles were recorded for </a:t>
            </a:r>
            <a:r>
              <a:rPr lang="en-NZ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pto</a:t>
            </a:r>
            <a:r>
              <a:rPr lang="en-NZ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x individual fruits from each line and found to progress within the range of 180° (green), 90</a:t>
            </a:r>
            <a:r>
              <a:rPr lang="en-NZ" sz="1100">
                <a:latin typeface="Times New Roman" panose="02020603050405020304" pitchFamily="18" charset="0"/>
                <a:cs typeface="Times New Roman" panose="02020603050405020304" pitchFamily="18" charset="0"/>
              </a:rPr>
              <a:t>° </a:t>
            </a:r>
            <a:r>
              <a:rPr lang="en-NZ" sz="1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yellow</a:t>
            </a:r>
            <a:r>
              <a:rPr lang="en-NZ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0° (red). Data from all lines are shown in supplemental data.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DA699504-4587-F55B-A69B-04CDD61E212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6089"/>
          <a:stretch/>
        </p:blipFill>
        <p:spPr>
          <a:xfrm>
            <a:off x="269765" y="623604"/>
            <a:ext cx="1589923" cy="1208313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BC90F70B-3C52-8468-710A-0391CA9E495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6089"/>
          <a:stretch/>
        </p:blipFill>
        <p:spPr>
          <a:xfrm>
            <a:off x="1826022" y="577681"/>
            <a:ext cx="1587738" cy="1208313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8375AEB7-1BD1-8BE3-9D77-682FEA6AA9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9800" y="1893784"/>
            <a:ext cx="1589888" cy="144000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666AE739-DF11-06E4-A236-BAA27E94E7C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93553" y="1887692"/>
            <a:ext cx="1585958" cy="1440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9CDCA05-CDDD-65BC-02DF-ECEC93BE82CD}"/>
              </a:ext>
            </a:extLst>
          </p:cNvPr>
          <p:cNvSpPr txBox="1"/>
          <p:nvPr/>
        </p:nvSpPr>
        <p:spPr>
          <a:xfrm>
            <a:off x="135951" y="531758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err="1"/>
              <a:t>Wt</a:t>
            </a:r>
            <a:endParaRPr lang="en-NZ" sz="10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7873615-D0E0-3FD7-6B03-D606A85D91D3}"/>
              </a:ext>
            </a:extLst>
          </p:cNvPr>
          <p:cNvSpPr txBox="1"/>
          <p:nvPr/>
        </p:nvSpPr>
        <p:spPr>
          <a:xfrm>
            <a:off x="1580282" y="531759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i="1" dirty="0"/>
              <a:t>MADS8a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858715E-6311-2A84-B2BD-238F3C57511F}"/>
              </a:ext>
            </a:extLst>
          </p:cNvPr>
          <p:cNvSpPr txBox="1"/>
          <p:nvPr/>
        </p:nvSpPr>
        <p:spPr>
          <a:xfrm>
            <a:off x="144767" y="1824786"/>
            <a:ext cx="3241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/>
              <a:t>A9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D81AAB0-96E6-D0A7-C1D2-6D17E7096CFB}"/>
              </a:ext>
            </a:extLst>
          </p:cNvPr>
          <p:cNvSpPr txBox="1"/>
          <p:nvPr/>
        </p:nvSpPr>
        <p:spPr>
          <a:xfrm>
            <a:off x="1709041" y="1824786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/>
              <a:t>A11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E0DB001C-C53E-835C-0761-F808A78B887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32226" y="507760"/>
            <a:ext cx="1595242" cy="144000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2F08AF70-4D38-C7F5-C27F-5C467461406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35078" y="1824786"/>
            <a:ext cx="1589539" cy="144000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83574910-5A59-41F2-8BB1-9B1E559B0C3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41182" y="1824786"/>
            <a:ext cx="1584000" cy="1440000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BDAB7BB5-FC6C-7760-AA9F-309312640D36}"/>
              </a:ext>
            </a:extLst>
          </p:cNvPr>
          <p:cNvSpPr txBox="1"/>
          <p:nvPr/>
        </p:nvSpPr>
        <p:spPr>
          <a:xfrm>
            <a:off x="3379511" y="506376"/>
            <a:ext cx="4074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/>
              <a:t>Wt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300BE2A-833A-E5F0-DF3E-0B1285F7A315}"/>
              </a:ext>
            </a:extLst>
          </p:cNvPr>
          <p:cNvSpPr txBox="1"/>
          <p:nvPr/>
        </p:nvSpPr>
        <p:spPr>
          <a:xfrm>
            <a:off x="3338371" y="1887692"/>
            <a:ext cx="3241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/>
              <a:t>A5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6F36288-6710-8595-3B91-C2BC0E6CF294}"/>
              </a:ext>
            </a:extLst>
          </p:cNvPr>
          <p:cNvSpPr txBox="1"/>
          <p:nvPr/>
        </p:nvSpPr>
        <p:spPr>
          <a:xfrm>
            <a:off x="5129216" y="1887692"/>
            <a:ext cx="3241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/>
              <a:t>A6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CD9AB2F-990B-6C17-2009-2CC9D774AB2D}"/>
              </a:ext>
            </a:extLst>
          </p:cNvPr>
          <p:cNvSpPr txBox="1"/>
          <p:nvPr/>
        </p:nvSpPr>
        <p:spPr>
          <a:xfrm>
            <a:off x="117733" y="228031"/>
            <a:ext cx="28907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dirty="0"/>
              <a:t>Additional Data 3. Colour change in all lines</a:t>
            </a:r>
          </a:p>
        </p:txBody>
      </p:sp>
    </p:spTree>
    <p:extLst>
      <p:ext uri="{BB962C8B-B14F-4D97-AF65-F5344CB8AC3E}">
        <p14:creationId xmlns:p14="http://schemas.microsoft.com/office/powerpoint/2010/main" val="3495870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6</Words>
  <Application>Microsoft Office PowerPoint</Application>
  <PresentationFormat>A4-Papier (210 x 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Company>Plant &amp; Food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Schaffer</dc:creator>
  <cp:lastModifiedBy>Brigitte</cp:lastModifiedBy>
  <cp:revision>9</cp:revision>
  <dcterms:created xsi:type="dcterms:W3CDTF">2021-10-18T00:31:37Z</dcterms:created>
  <dcterms:modified xsi:type="dcterms:W3CDTF">2025-01-22T11:43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8d8f3512-c98a-4fbc-ad6e-3260f1cde3f8_Enabled">
    <vt:lpwstr>true</vt:lpwstr>
  </property>
  <property fmtid="{D5CDD505-2E9C-101B-9397-08002B2CF9AE}" pid="3" name="MSIP_Label_8d8f3512-c98a-4fbc-ad6e-3260f1cde3f8_SetDate">
    <vt:lpwstr>2024-10-21T22:09:08Z</vt:lpwstr>
  </property>
  <property fmtid="{D5CDD505-2E9C-101B-9397-08002B2CF9AE}" pid="4" name="MSIP_Label_8d8f3512-c98a-4fbc-ad6e-3260f1cde3f8_Method">
    <vt:lpwstr>Standard</vt:lpwstr>
  </property>
  <property fmtid="{D5CDD505-2E9C-101B-9397-08002B2CF9AE}" pid="5" name="MSIP_Label_8d8f3512-c98a-4fbc-ad6e-3260f1cde3f8_Name">
    <vt:lpwstr>Internal</vt:lpwstr>
  </property>
  <property fmtid="{D5CDD505-2E9C-101B-9397-08002B2CF9AE}" pid="6" name="MSIP_Label_8d8f3512-c98a-4fbc-ad6e-3260f1cde3f8_SiteId">
    <vt:lpwstr>6ca75ef7-2c66-42e7-af2c-6502153a7e3a</vt:lpwstr>
  </property>
  <property fmtid="{D5CDD505-2E9C-101B-9397-08002B2CF9AE}" pid="7" name="MSIP_Label_8d8f3512-c98a-4fbc-ad6e-3260f1cde3f8_ActionId">
    <vt:lpwstr>914ec625-308d-4b51-bd43-6d1de01e539d</vt:lpwstr>
  </property>
  <property fmtid="{D5CDD505-2E9C-101B-9397-08002B2CF9AE}" pid="8" name="MSIP_Label_8d8f3512-c98a-4fbc-ad6e-3260f1cde3f8_ContentBits">
    <vt:lpwstr>0</vt:lpwstr>
  </property>
</Properties>
</file>